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8.xml.rels" ContentType="application/vnd.openxmlformats-package.relationships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97B612-8E65-4008-B6E0-4464DD59488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E86BBD-57D5-4E36-8D77-C858611C3B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2C9716-B800-4CCF-85AC-7912114931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741B92-35DC-4257-BF58-48CA13BA72B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EAC201-0366-4D61-B904-592189DBE5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C43586-A66B-43F5-92B0-C49435F378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888469-CCDD-44F9-9158-ECCEB9E99D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A7A855-B0F5-4EC9-8ACF-8CB49FB84C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7FCF56-FEAE-4620-AA60-B0C0386904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17F350-B738-4B31-86DB-0D75AF36A7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1E209A-BB59-4ADA-ABF3-659118D2D2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FC9723-F89D-4FC1-ADEA-DA183B1D3C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030367-9BE5-42E6-BA68-26D86AB9B6C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Base" hidden="1"/>
          <p:cNvSpPr/>
          <p:nvPr/>
        </p:nvSpPr>
        <p:spPr>
          <a:xfrm>
            <a:off x="1523880" y="1397160"/>
            <a:ext cx="6096240" cy="406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"/>
          <p:cNvSpPr/>
          <p:nvPr/>
        </p:nvSpPr>
        <p:spPr>
          <a:xfrm>
            <a:off x="2086200" y="1717560"/>
            <a:ext cx="470844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ffff"/>
                </a:solidFill>
                <a:latin typeface="Times New Roman"/>
              </a:rPr>
              <a:t>Additional File 7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ffffff"/>
                </a:solidFill>
                <a:latin typeface="Times New Roman"/>
              </a:rPr>
              <a:t>K-means cluster graphs (15 clusters)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" descr=""/>
          <p:cNvPicPr/>
          <p:nvPr/>
        </p:nvPicPr>
        <p:blipFill>
          <a:blip r:embed="rId1"/>
          <a:srcRect l="74578" t="21344" r="0" b="56553"/>
          <a:stretch/>
        </p:blipFill>
        <p:spPr>
          <a:xfrm>
            <a:off x="838080" y="380880"/>
            <a:ext cx="7010640" cy="6334200"/>
          </a:xfrm>
          <a:prstGeom prst="rect">
            <a:avLst/>
          </a:prstGeom>
          <a:ln w="0">
            <a:noFill/>
          </a:ln>
        </p:spPr>
      </p:pic>
      <p:sp>
        <p:nvSpPr>
          <p:cNvPr id="111" name=""/>
          <p:cNvSpPr/>
          <p:nvPr/>
        </p:nvSpPr>
        <p:spPr>
          <a:xfrm rot="16200000">
            <a:off x="2943360" y="4372560"/>
            <a:ext cx="759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1/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 rot="16200000">
            <a:off x="1603440" y="4570200"/>
            <a:ext cx="392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 rot="16200000">
            <a:off x="1518840" y="4196160"/>
            <a:ext cx="1171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 rot="16200000">
            <a:off x="1815120" y="4128840"/>
            <a:ext cx="134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iddl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 rot="16200000">
            <a:off x="2323080" y="4229280"/>
            <a:ext cx="1086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 rot="16200000">
            <a:off x="3204360" y="4264560"/>
            <a:ext cx="1000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 rot="16200000">
            <a:off x="3628080" y="4297680"/>
            <a:ext cx="91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 rot="16200000">
            <a:off x="4206240" y="4557240"/>
            <a:ext cx="520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2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4881600" y="1219320"/>
            <a:ext cx="341316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This set mostly includes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ribosomal subunit genes as well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as genes encoding beta-actin,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beta-5-tubulin, and myosin light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polypeptide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0" name="" descr=""/>
          <p:cNvPicPr/>
          <p:nvPr/>
        </p:nvPicPr>
        <p:blipFill>
          <a:blip r:embed="rId1"/>
          <a:srcRect l="0" t="43450" r="75426" b="34446"/>
          <a:stretch/>
        </p:blipFill>
        <p:spPr>
          <a:xfrm>
            <a:off x="1295280" y="304920"/>
            <a:ext cx="6705720" cy="6324480"/>
          </a:xfrm>
          <a:prstGeom prst="rect">
            <a:avLst/>
          </a:prstGeom>
          <a:ln w="0">
            <a:noFill/>
          </a:ln>
        </p:spPr>
      </p:pic>
      <p:sp>
        <p:nvSpPr>
          <p:cNvPr id="121" name=""/>
          <p:cNvSpPr/>
          <p:nvPr/>
        </p:nvSpPr>
        <p:spPr>
          <a:xfrm rot="16200000">
            <a:off x="3248280" y="4143960"/>
            <a:ext cx="759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1/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 rot="16200000">
            <a:off x="1908360" y="4341600"/>
            <a:ext cx="392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 rot="16200000">
            <a:off x="1899720" y="3967560"/>
            <a:ext cx="1171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 rot="16200000">
            <a:off x="2196000" y="3900240"/>
            <a:ext cx="134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iddl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 rot="16200000">
            <a:off x="2704320" y="4000680"/>
            <a:ext cx="1086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 rot="16200000">
            <a:off x="3432960" y="4035960"/>
            <a:ext cx="1000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 rot="16200000">
            <a:off x="3856680" y="4069080"/>
            <a:ext cx="91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 rot="16200000">
            <a:off x="4511160" y="4252680"/>
            <a:ext cx="520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2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9" name="" descr=""/>
          <p:cNvPicPr/>
          <p:nvPr/>
        </p:nvPicPr>
        <p:blipFill>
          <a:blip r:embed="rId1"/>
          <a:srcRect l="24577" t="43450" r="50001" b="34446"/>
          <a:stretch/>
        </p:blipFill>
        <p:spPr>
          <a:xfrm>
            <a:off x="762120" y="533520"/>
            <a:ext cx="6629400" cy="6113520"/>
          </a:xfrm>
          <a:prstGeom prst="rect">
            <a:avLst/>
          </a:prstGeom>
          <a:ln w="0">
            <a:noFill/>
          </a:ln>
        </p:spPr>
      </p:pic>
      <p:grpSp>
        <p:nvGrpSpPr>
          <p:cNvPr id="130" name=""/>
          <p:cNvGrpSpPr/>
          <p:nvPr/>
        </p:nvGrpSpPr>
        <p:grpSpPr>
          <a:xfrm>
            <a:off x="1447920" y="3505680"/>
            <a:ext cx="2913480" cy="1340640"/>
            <a:chOff x="1447920" y="3505680"/>
            <a:chExt cx="2913480" cy="1340640"/>
          </a:xfrm>
        </p:grpSpPr>
        <p:sp>
          <p:nvSpPr>
            <p:cNvPr id="131" name=""/>
            <p:cNvSpPr/>
            <p:nvPr/>
          </p:nvSpPr>
          <p:spPr>
            <a:xfrm rot="16200000">
              <a:off x="2715120" y="4219560"/>
              <a:ext cx="7599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cccff"/>
                  </a:solidFill>
                  <a:latin typeface="Arial"/>
                  <a:ea typeface="Arial"/>
                </a:rPr>
                <a:t>G1/S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"/>
            <p:cNvSpPr/>
            <p:nvPr/>
          </p:nvSpPr>
          <p:spPr>
            <a:xfrm rot="16200000">
              <a:off x="1451160" y="4417920"/>
              <a:ext cx="3924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cccff"/>
                  </a:solidFill>
                  <a:latin typeface="Arial"/>
                  <a:ea typeface="Arial"/>
                </a:rPr>
                <a:t>M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"/>
            <p:cNvSpPr/>
            <p:nvPr/>
          </p:nvSpPr>
          <p:spPr>
            <a:xfrm rot="16200000">
              <a:off x="1366560" y="4043880"/>
              <a:ext cx="11714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cccff"/>
                  </a:solidFill>
                  <a:latin typeface="Arial"/>
                  <a:ea typeface="Arial"/>
                </a:rPr>
                <a:t>Early G1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4" name=""/>
            <p:cNvSpPr/>
            <p:nvPr/>
          </p:nvSpPr>
          <p:spPr>
            <a:xfrm rot="16200000">
              <a:off x="1739160" y="3976560"/>
              <a:ext cx="13406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cccff"/>
                  </a:solidFill>
                  <a:latin typeface="Arial"/>
                  <a:ea typeface="Arial"/>
                </a:rPr>
                <a:t>Middle G1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5" name=""/>
            <p:cNvSpPr/>
            <p:nvPr/>
          </p:nvSpPr>
          <p:spPr>
            <a:xfrm rot="16200000">
              <a:off x="2170800" y="4077000"/>
              <a:ext cx="10861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cccff"/>
                  </a:solidFill>
                  <a:latin typeface="Arial"/>
                  <a:ea typeface="Arial"/>
                </a:rPr>
                <a:t>Late G1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6" name=""/>
            <p:cNvSpPr/>
            <p:nvPr/>
          </p:nvSpPr>
          <p:spPr>
            <a:xfrm rot="16200000">
              <a:off x="2975760" y="4111920"/>
              <a:ext cx="10008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cccff"/>
                  </a:solidFill>
                  <a:latin typeface="Arial"/>
                  <a:ea typeface="Arial"/>
                </a:rPr>
                <a:t>Early S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"/>
            <p:cNvSpPr/>
            <p:nvPr/>
          </p:nvSpPr>
          <p:spPr>
            <a:xfrm rot="16200000">
              <a:off x="3323520" y="4145400"/>
              <a:ext cx="9151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cccff"/>
                  </a:solidFill>
                  <a:latin typeface="Arial"/>
                  <a:ea typeface="Arial"/>
                </a:rPr>
                <a:t>Late S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8" name=""/>
            <p:cNvSpPr/>
            <p:nvPr/>
          </p:nvSpPr>
          <p:spPr>
            <a:xfrm rot="16200000">
              <a:off x="3901680" y="4328640"/>
              <a:ext cx="5205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cccff"/>
                  </a:solidFill>
                  <a:latin typeface="Arial"/>
                  <a:ea typeface="Arial"/>
                </a:rPr>
                <a:t>G2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39" name=""/>
          <p:cNvSpPr/>
          <p:nvPr/>
        </p:nvSpPr>
        <p:spPr>
          <a:xfrm flipH="1" flipV="1">
            <a:off x="2971800" y="2514600"/>
            <a:ext cx="914400" cy="838080"/>
          </a:xfrm>
          <a:prstGeom prst="line">
            <a:avLst/>
          </a:prstGeom>
          <a:ln w="38160">
            <a:solidFill>
              <a:srgbClr val="66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3945600" y="3048120"/>
            <a:ext cx="519624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Increased expression of genes including those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encoding cathepsins L, L2, and Z, PPGB, EGFR,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lamin B, poliovirus, leptin, MHC molecules,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and solute/ion carrier transporters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1" name="" descr=""/>
          <p:cNvPicPr/>
          <p:nvPr/>
        </p:nvPicPr>
        <p:blipFill>
          <a:blip r:embed="rId1"/>
          <a:srcRect l="49153" t="43450" r="25425" b="34446"/>
          <a:stretch/>
        </p:blipFill>
        <p:spPr>
          <a:xfrm>
            <a:off x="1066680" y="533520"/>
            <a:ext cx="6629400" cy="6040440"/>
          </a:xfrm>
          <a:prstGeom prst="rect">
            <a:avLst/>
          </a:prstGeom>
          <a:ln w="0">
            <a:noFill/>
          </a:ln>
        </p:spPr>
      </p:pic>
      <p:sp>
        <p:nvSpPr>
          <p:cNvPr id="142" name=""/>
          <p:cNvSpPr/>
          <p:nvPr/>
        </p:nvSpPr>
        <p:spPr>
          <a:xfrm rot="16200000">
            <a:off x="3096000" y="4219560"/>
            <a:ext cx="759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1/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 rot="16200000">
            <a:off x="1832040" y="4417920"/>
            <a:ext cx="392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 rot="16200000">
            <a:off x="1823400" y="4043880"/>
            <a:ext cx="1171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 rot="16200000">
            <a:off x="2120040" y="3976560"/>
            <a:ext cx="134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iddl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 rot="16200000">
            <a:off x="2551680" y="4077000"/>
            <a:ext cx="1086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 rot="16200000">
            <a:off x="3356640" y="4111920"/>
            <a:ext cx="1000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 rot="16200000">
            <a:off x="3780360" y="4145400"/>
            <a:ext cx="91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 rot="16200000">
            <a:off x="4358880" y="4328640"/>
            <a:ext cx="520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2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0" name="" descr=""/>
          <p:cNvPicPr/>
          <p:nvPr/>
        </p:nvPicPr>
        <p:blipFill>
          <a:blip r:embed="rId1"/>
          <a:srcRect l="74578" t="43450" r="0" b="34446"/>
          <a:stretch/>
        </p:blipFill>
        <p:spPr>
          <a:xfrm>
            <a:off x="1143000" y="457200"/>
            <a:ext cx="6705720" cy="6113520"/>
          </a:xfrm>
          <a:prstGeom prst="rect">
            <a:avLst/>
          </a:prstGeom>
          <a:ln w="0">
            <a:noFill/>
          </a:ln>
        </p:spPr>
      </p:pic>
      <p:sp>
        <p:nvSpPr>
          <p:cNvPr id="151" name=""/>
          <p:cNvSpPr/>
          <p:nvPr/>
        </p:nvSpPr>
        <p:spPr>
          <a:xfrm rot="16200000">
            <a:off x="3171960" y="4143960"/>
            <a:ext cx="759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1/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 rot="16200000">
            <a:off x="1832040" y="4341600"/>
            <a:ext cx="392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 rot="16200000">
            <a:off x="1747440" y="3967560"/>
            <a:ext cx="1171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 rot="16200000">
            <a:off x="2120040" y="3823920"/>
            <a:ext cx="134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iddl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 rot="16200000">
            <a:off x="2628000" y="4000680"/>
            <a:ext cx="1086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 rot="16200000">
            <a:off x="3356640" y="4035960"/>
            <a:ext cx="1000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"/>
          <p:cNvSpPr/>
          <p:nvPr/>
        </p:nvSpPr>
        <p:spPr>
          <a:xfrm rot="16200000">
            <a:off x="3780360" y="4069080"/>
            <a:ext cx="91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 rot="16200000">
            <a:off x="4358880" y="4252680"/>
            <a:ext cx="520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2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9" name="" descr=""/>
          <p:cNvPicPr/>
          <p:nvPr/>
        </p:nvPicPr>
        <p:blipFill>
          <a:blip r:embed="rId1"/>
          <a:srcRect l="0" t="65563" r="75002" b="12223"/>
          <a:stretch/>
        </p:blipFill>
        <p:spPr>
          <a:xfrm>
            <a:off x="838080" y="533520"/>
            <a:ext cx="7467840" cy="6095880"/>
          </a:xfrm>
          <a:prstGeom prst="rect">
            <a:avLst/>
          </a:prstGeom>
          <a:ln w="0">
            <a:noFill/>
          </a:ln>
        </p:spPr>
      </p:pic>
      <p:sp>
        <p:nvSpPr>
          <p:cNvPr id="160" name=""/>
          <p:cNvSpPr/>
          <p:nvPr/>
        </p:nvSpPr>
        <p:spPr>
          <a:xfrm rot="16200000">
            <a:off x="3019680" y="4067280"/>
            <a:ext cx="759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1/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 rot="16200000">
            <a:off x="1527120" y="4265280"/>
            <a:ext cx="392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 rot="16200000">
            <a:off x="1518840" y="3891600"/>
            <a:ext cx="1171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"/>
          <p:cNvSpPr/>
          <p:nvPr/>
        </p:nvSpPr>
        <p:spPr>
          <a:xfrm rot="16200000">
            <a:off x="1815120" y="3823920"/>
            <a:ext cx="134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iddl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"/>
          <p:cNvSpPr/>
          <p:nvPr/>
        </p:nvSpPr>
        <p:spPr>
          <a:xfrm rot="16200000">
            <a:off x="2399400" y="3924360"/>
            <a:ext cx="1086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"/>
          <p:cNvSpPr/>
          <p:nvPr/>
        </p:nvSpPr>
        <p:spPr>
          <a:xfrm rot="16200000">
            <a:off x="3280320" y="3959640"/>
            <a:ext cx="1000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 rot="16200000">
            <a:off x="3780360" y="3993120"/>
            <a:ext cx="91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 rot="16200000">
            <a:off x="4358880" y="4176360"/>
            <a:ext cx="520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2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8" name="" descr=""/>
          <p:cNvPicPr/>
          <p:nvPr/>
        </p:nvPicPr>
        <p:blipFill>
          <a:blip r:embed="rId1"/>
          <a:srcRect l="25001" t="64469" r="50001" b="12223"/>
          <a:stretch/>
        </p:blipFill>
        <p:spPr>
          <a:xfrm>
            <a:off x="1143000" y="304920"/>
            <a:ext cx="7010280" cy="6324480"/>
          </a:xfrm>
          <a:prstGeom prst="rect">
            <a:avLst/>
          </a:prstGeom>
          <a:ln w="0">
            <a:noFill/>
          </a:ln>
        </p:spPr>
      </p:pic>
      <p:sp>
        <p:nvSpPr>
          <p:cNvPr id="169" name=""/>
          <p:cNvSpPr/>
          <p:nvPr/>
        </p:nvSpPr>
        <p:spPr>
          <a:xfrm rot="16200000">
            <a:off x="3096000" y="4067280"/>
            <a:ext cx="759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1/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 rot="16200000">
            <a:off x="1755720" y="4265280"/>
            <a:ext cx="392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"/>
          <p:cNvSpPr/>
          <p:nvPr/>
        </p:nvSpPr>
        <p:spPr>
          <a:xfrm rot="16200000">
            <a:off x="1747440" y="3891600"/>
            <a:ext cx="1171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"/>
          <p:cNvSpPr/>
          <p:nvPr/>
        </p:nvSpPr>
        <p:spPr>
          <a:xfrm rot="16200000">
            <a:off x="2043720" y="3823920"/>
            <a:ext cx="134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iddl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"/>
          <p:cNvSpPr/>
          <p:nvPr/>
        </p:nvSpPr>
        <p:spPr>
          <a:xfrm rot="16200000">
            <a:off x="2551680" y="3924360"/>
            <a:ext cx="1086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"/>
          <p:cNvSpPr/>
          <p:nvPr/>
        </p:nvSpPr>
        <p:spPr>
          <a:xfrm rot="16200000">
            <a:off x="3432960" y="3959640"/>
            <a:ext cx="1000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"/>
          <p:cNvSpPr/>
          <p:nvPr/>
        </p:nvSpPr>
        <p:spPr>
          <a:xfrm rot="16200000">
            <a:off x="3856680" y="4069080"/>
            <a:ext cx="91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 rot="16200000">
            <a:off x="4434840" y="4252680"/>
            <a:ext cx="520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2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7" name="" descr=""/>
          <p:cNvPicPr/>
          <p:nvPr/>
        </p:nvPicPr>
        <p:blipFill>
          <a:blip r:embed="rId1"/>
          <a:srcRect l="50001" t="64469" r="25001" b="12223"/>
          <a:stretch/>
        </p:blipFill>
        <p:spPr>
          <a:xfrm>
            <a:off x="685800" y="228600"/>
            <a:ext cx="7391520" cy="6324480"/>
          </a:xfrm>
          <a:prstGeom prst="rect">
            <a:avLst/>
          </a:prstGeom>
          <a:ln w="0">
            <a:noFill/>
          </a:ln>
        </p:spPr>
      </p:pic>
      <p:sp>
        <p:nvSpPr>
          <p:cNvPr id="178" name=""/>
          <p:cNvSpPr/>
          <p:nvPr/>
        </p:nvSpPr>
        <p:spPr>
          <a:xfrm rot="16200000">
            <a:off x="2791080" y="4067280"/>
            <a:ext cx="759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1/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"/>
          <p:cNvSpPr/>
          <p:nvPr/>
        </p:nvSpPr>
        <p:spPr>
          <a:xfrm rot="16200000">
            <a:off x="1374840" y="4189320"/>
            <a:ext cx="392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"/>
          <p:cNvSpPr/>
          <p:nvPr/>
        </p:nvSpPr>
        <p:spPr>
          <a:xfrm rot="16200000">
            <a:off x="1366200" y="3891600"/>
            <a:ext cx="1171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"/>
          <p:cNvSpPr/>
          <p:nvPr/>
        </p:nvSpPr>
        <p:spPr>
          <a:xfrm rot="16200000">
            <a:off x="1662840" y="3747960"/>
            <a:ext cx="134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iddl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"/>
          <p:cNvSpPr/>
          <p:nvPr/>
        </p:nvSpPr>
        <p:spPr>
          <a:xfrm rot="16200000">
            <a:off x="2247120" y="3924360"/>
            <a:ext cx="1086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"/>
          <p:cNvSpPr/>
          <p:nvPr/>
        </p:nvSpPr>
        <p:spPr>
          <a:xfrm rot="16200000">
            <a:off x="3128040" y="3959640"/>
            <a:ext cx="1000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"/>
          <p:cNvSpPr/>
          <p:nvPr/>
        </p:nvSpPr>
        <p:spPr>
          <a:xfrm rot="16200000">
            <a:off x="3551760" y="3993120"/>
            <a:ext cx="91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"/>
          <p:cNvSpPr/>
          <p:nvPr/>
        </p:nvSpPr>
        <p:spPr>
          <a:xfrm rot="16200000">
            <a:off x="4130280" y="4176360"/>
            <a:ext cx="520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2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rcRect l="0" t="0" r="0" b="12223"/>
          <a:stretch/>
        </p:blipFill>
        <p:spPr>
          <a:xfrm>
            <a:off x="0" y="304920"/>
            <a:ext cx="9144000" cy="6553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rcRect l="0" t="0" r="75426" b="77896"/>
          <a:stretch/>
        </p:blipFill>
        <p:spPr>
          <a:xfrm>
            <a:off x="1295280" y="0"/>
            <a:ext cx="7315200" cy="6292800"/>
          </a:xfrm>
          <a:prstGeom prst="rect">
            <a:avLst/>
          </a:prstGeom>
          <a:ln w="0">
            <a:noFill/>
          </a:ln>
        </p:spPr>
      </p:pic>
      <p:grpSp>
        <p:nvGrpSpPr>
          <p:cNvPr id="45" name=""/>
          <p:cNvGrpSpPr/>
          <p:nvPr/>
        </p:nvGrpSpPr>
        <p:grpSpPr>
          <a:xfrm>
            <a:off x="1981080" y="3200760"/>
            <a:ext cx="3294720" cy="1340640"/>
            <a:chOff x="1981080" y="3200760"/>
            <a:chExt cx="3294720" cy="1340640"/>
          </a:xfrm>
        </p:grpSpPr>
        <p:sp>
          <p:nvSpPr>
            <p:cNvPr id="46" name=""/>
            <p:cNvSpPr/>
            <p:nvPr/>
          </p:nvSpPr>
          <p:spPr>
            <a:xfrm rot="16200000">
              <a:off x="3400560" y="3915360"/>
              <a:ext cx="7599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cccff"/>
                  </a:solidFill>
                  <a:latin typeface="Arial"/>
                  <a:ea typeface="Arial"/>
                </a:rPr>
                <a:t>G1/S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 rot="16200000">
              <a:off x="1984320" y="4113000"/>
              <a:ext cx="3924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cccff"/>
                  </a:solidFill>
                  <a:latin typeface="Arial"/>
                  <a:ea typeface="Arial"/>
                </a:rPr>
                <a:t>M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 rot="16200000">
              <a:off x="1976040" y="3738960"/>
              <a:ext cx="11714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cccff"/>
                  </a:solidFill>
                  <a:latin typeface="Arial"/>
                  <a:ea typeface="Arial"/>
                </a:rPr>
                <a:t>Early G1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 rot="16200000">
              <a:off x="2272320" y="3671640"/>
              <a:ext cx="13406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cccff"/>
                  </a:solidFill>
                  <a:latin typeface="Arial"/>
                  <a:ea typeface="Arial"/>
                </a:rPr>
                <a:t>Middle G1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 rot="16200000">
              <a:off x="2856600" y="3772080"/>
              <a:ext cx="10861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cccff"/>
                  </a:solidFill>
                  <a:latin typeface="Arial"/>
                  <a:ea typeface="Arial"/>
                </a:rPr>
                <a:t>Late G1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 rot="16200000">
              <a:off x="3737520" y="3807360"/>
              <a:ext cx="10008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cccff"/>
                  </a:solidFill>
                  <a:latin typeface="Arial"/>
                  <a:ea typeface="Arial"/>
                </a:rPr>
                <a:t>Early S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 rot="16200000">
              <a:off x="4161600" y="3840480"/>
              <a:ext cx="9151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cccff"/>
                  </a:solidFill>
                  <a:latin typeface="Arial"/>
                  <a:ea typeface="Arial"/>
                </a:rPr>
                <a:t>Late S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 rot="16200000">
              <a:off x="4816080" y="4024080"/>
              <a:ext cx="5205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cccff"/>
                  </a:solidFill>
                  <a:latin typeface="Arial"/>
                  <a:ea typeface="Arial"/>
                </a:rPr>
                <a:t>G2</a:t>
              </a:r>
              <a:endParaRPr b="0" lang="en-US" sz="2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" descr=""/>
          <p:cNvPicPr/>
          <p:nvPr/>
        </p:nvPicPr>
        <p:blipFill>
          <a:blip r:embed="rId1"/>
          <a:srcRect l="24577" t="0" r="50001" b="77896"/>
          <a:stretch/>
        </p:blipFill>
        <p:spPr>
          <a:xfrm>
            <a:off x="990720" y="376200"/>
            <a:ext cx="7315200" cy="6481800"/>
          </a:xfrm>
          <a:prstGeom prst="rect">
            <a:avLst/>
          </a:prstGeom>
          <a:ln w="0">
            <a:noFill/>
          </a:ln>
        </p:spPr>
      </p:pic>
      <p:sp>
        <p:nvSpPr>
          <p:cNvPr id="55" name=""/>
          <p:cNvSpPr/>
          <p:nvPr/>
        </p:nvSpPr>
        <p:spPr>
          <a:xfrm rot="16200000">
            <a:off x="3171960" y="4372560"/>
            <a:ext cx="759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1/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 rot="16200000">
            <a:off x="1755720" y="4570200"/>
            <a:ext cx="392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 rot="16200000">
            <a:off x="1747440" y="4196160"/>
            <a:ext cx="1171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 rot="16200000">
            <a:off x="2043720" y="4128840"/>
            <a:ext cx="134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iddl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 rot="16200000">
            <a:off x="2628000" y="4229280"/>
            <a:ext cx="1086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 rot="16200000">
            <a:off x="3432960" y="4264560"/>
            <a:ext cx="1000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 rot="16200000">
            <a:off x="3856680" y="4297680"/>
            <a:ext cx="91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 rot="16200000">
            <a:off x="4511160" y="4481280"/>
            <a:ext cx="520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2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" descr=""/>
          <p:cNvPicPr/>
          <p:nvPr/>
        </p:nvPicPr>
        <p:blipFill>
          <a:blip r:embed="rId1"/>
          <a:srcRect l="49153" t="0" r="25425" b="77896"/>
          <a:stretch/>
        </p:blipFill>
        <p:spPr>
          <a:xfrm>
            <a:off x="990720" y="228600"/>
            <a:ext cx="6933960" cy="6335640"/>
          </a:xfrm>
          <a:prstGeom prst="rect">
            <a:avLst/>
          </a:prstGeom>
          <a:ln w="0">
            <a:noFill/>
          </a:ln>
        </p:spPr>
      </p:pic>
      <p:sp>
        <p:nvSpPr>
          <p:cNvPr id="64" name=""/>
          <p:cNvSpPr/>
          <p:nvPr/>
        </p:nvSpPr>
        <p:spPr>
          <a:xfrm rot="16200000">
            <a:off x="3171960" y="4143960"/>
            <a:ext cx="759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1/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 rot="16200000">
            <a:off x="1832040" y="4341600"/>
            <a:ext cx="392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 rot="16200000">
            <a:off x="1823400" y="3967560"/>
            <a:ext cx="1171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 rot="16200000">
            <a:off x="2120040" y="3900240"/>
            <a:ext cx="134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iddl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 rot="16200000">
            <a:off x="2628000" y="4000680"/>
            <a:ext cx="1086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 rot="16200000">
            <a:off x="3432960" y="4035960"/>
            <a:ext cx="1000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 rot="16200000">
            <a:off x="3856680" y="4069080"/>
            <a:ext cx="91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 rot="16200000">
            <a:off x="4434840" y="4252680"/>
            <a:ext cx="520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2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" descr=""/>
          <p:cNvPicPr/>
          <p:nvPr/>
        </p:nvPicPr>
        <p:blipFill>
          <a:blip r:embed="rId1"/>
          <a:srcRect l="74578" t="0" r="0" b="77896"/>
          <a:stretch/>
        </p:blipFill>
        <p:spPr>
          <a:xfrm>
            <a:off x="838080" y="376200"/>
            <a:ext cx="6705720" cy="6481800"/>
          </a:xfrm>
          <a:prstGeom prst="rect">
            <a:avLst/>
          </a:prstGeom>
          <a:ln w="0">
            <a:noFill/>
          </a:ln>
        </p:spPr>
      </p:pic>
      <p:sp>
        <p:nvSpPr>
          <p:cNvPr id="73" name=""/>
          <p:cNvSpPr/>
          <p:nvPr/>
        </p:nvSpPr>
        <p:spPr>
          <a:xfrm rot="16200000">
            <a:off x="2867400" y="4372560"/>
            <a:ext cx="759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1/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 rot="16200000">
            <a:off x="1527120" y="4570200"/>
            <a:ext cx="392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 rot="16200000">
            <a:off x="1518840" y="4196160"/>
            <a:ext cx="1171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 rot="16200000">
            <a:off x="1815120" y="4128840"/>
            <a:ext cx="134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iddl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 rot="16200000">
            <a:off x="2247120" y="4229280"/>
            <a:ext cx="1086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 rot="16200000">
            <a:off x="3051720" y="4264560"/>
            <a:ext cx="1000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 rot="16200000">
            <a:off x="3475800" y="4297680"/>
            <a:ext cx="91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 rot="16200000">
            <a:off x="4053960" y="4481280"/>
            <a:ext cx="520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2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 flipH="1" flipV="1">
            <a:off x="3124080" y="2743200"/>
            <a:ext cx="1067040" cy="838080"/>
          </a:xfrm>
          <a:prstGeom prst="line">
            <a:avLst/>
          </a:prstGeom>
          <a:ln w="38160">
            <a:solidFill>
              <a:srgbClr val="6699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4269240" y="3024360"/>
            <a:ext cx="485316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Increased expression of genes including: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BAX, BAX inhibitor 1, TRAIL receptor 2, CD9,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EGFR, syndecan 4, signaling mediators, &amp;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genes involved in transcriptional regulation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" descr=""/>
          <p:cNvPicPr/>
          <p:nvPr/>
        </p:nvPicPr>
        <p:blipFill>
          <a:blip r:embed="rId1"/>
          <a:srcRect l="0" t="22107" r="75426" b="56553"/>
          <a:stretch/>
        </p:blipFill>
        <p:spPr>
          <a:xfrm>
            <a:off x="1219320" y="380880"/>
            <a:ext cx="6781680" cy="6180120"/>
          </a:xfrm>
          <a:prstGeom prst="rect">
            <a:avLst/>
          </a:prstGeom>
          <a:ln w="0">
            <a:noFill/>
          </a:ln>
        </p:spPr>
      </p:pic>
      <p:sp>
        <p:nvSpPr>
          <p:cNvPr id="84" name=""/>
          <p:cNvSpPr/>
          <p:nvPr/>
        </p:nvSpPr>
        <p:spPr>
          <a:xfrm rot="16200000">
            <a:off x="3171960" y="4219560"/>
            <a:ext cx="759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1/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 rot="16200000">
            <a:off x="1832040" y="4417920"/>
            <a:ext cx="392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 rot="16200000">
            <a:off x="1823400" y="4043880"/>
            <a:ext cx="1171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 rot="16200000">
            <a:off x="2120040" y="3976560"/>
            <a:ext cx="134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iddl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 rot="16200000">
            <a:off x="2628000" y="4077000"/>
            <a:ext cx="1086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 rot="16200000">
            <a:off x="3432960" y="4111920"/>
            <a:ext cx="1000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 rot="16200000">
            <a:off x="3856680" y="4145400"/>
            <a:ext cx="91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 rot="16200000">
            <a:off x="4434840" y="4328640"/>
            <a:ext cx="520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2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" descr=""/>
          <p:cNvPicPr/>
          <p:nvPr/>
        </p:nvPicPr>
        <p:blipFill>
          <a:blip r:embed="rId1"/>
          <a:srcRect l="24577" t="22107" r="50001" b="56553"/>
          <a:stretch/>
        </p:blipFill>
        <p:spPr>
          <a:xfrm>
            <a:off x="1295280" y="457200"/>
            <a:ext cx="7010640" cy="6188040"/>
          </a:xfrm>
          <a:prstGeom prst="rect">
            <a:avLst/>
          </a:prstGeom>
          <a:ln w="0">
            <a:noFill/>
          </a:ln>
        </p:spPr>
      </p:pic>
      <p:sp>
        <p:nvSpPr>
          <p:cNvPr id="93" name=""/>
          <p:cNvSpPr/>
          <p:nvPr/>
        </p:nvSpPr>
        <p:spPr>
          <a:xfrm rot="16200000">
            <a:off x="3400560" y="4295880"/>
            <a:ext cx="759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1/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 rot="16200000">
            <a:off x="2060640" y="4493880"/>
            <a:ext cx="392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 rot="16200000">
            <a:off x="1976040" y="4120200"/>
            <a:ext cx="1171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 rot="16200000">
            <a:off x="2272320" y="4052520"/>
            <a:ext cx="134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iddl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 rot="16200000">
            <a:off x="2780280" y="4152960"/>
            <a:ext cx="1086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 rot="16200000">
            <a:off x="3661560" y="4188240"/>
            <a:ext cx="1000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 rot="16200000">
            <a:off x="4085280" y="4221720"/>
            <a:ext cx="91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 rot="16200000">
            <a:off x="4663440" y="4404960"/>
            <a:ext cx="520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2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" descr=""/>
          <p:cNvPicPr/>
          <p:nvPr/>
        </p:nvPicPr>
        <p:blipFill>
          <a:blip r:embed="rId1"/>
          <a:srcRect l="50001" t="21344" r="25425" b="56553"/>
          <a:stretch/>
        </p:blipFill>
        <p:spPr>
          <a:xfrm>
            <a:off x="1295280" y="304920"/>
            <a:ext cx="6858000" cy="6324480"/>
          </a:xfrm>
          <a:prstGeom prst="rect">
            <a:avLst/>
          </a:prstGeom>
          <a:ln w="0">
            <a:noFill/>
          </a:ln>
        </p:spPr>
      </p:pic>
      <p:sp>
        <p:nvSpPr>
          <p:cNvPr id="102" name=""/>
          <p:cNvSpPr/>
          <p:nvPr/>
        </p:nvSpPr>
        <p:spPr>
          <a:xfrm rot="16200000">
            <a:off x="3248280" y="4295880"/>
            <a:ext cx="759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1/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 rot="16200000">
            <a:off x="1908360" y="4493880"/>
            <a:ext cx="392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 rot="16200000">
            <a:off x="1899720" y="4120200"/>
            <a:ext cx="1171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 rot="16200000">
            <a:off x="2196000" y="4052520"/>
            <a:ext cx="1340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Middl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 rot="16200000">
            <a:off x="2704320" y="4152960"/>
            <a:ext cx="1086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G1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 rot="16200000">
            <a:off x="3508920" y="4188240"/>
            <a:ext cx="1000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Early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 rot="16200000">
            <a:off x="4008960" y="4221720"/>
            <a:ext cx="915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Late S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 rot="16200000">
            <a:off x="4587480" y="4404960"/>
            <a:ext cx="520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ccccff"/>
                </a:solidFill>
                <a:latin typeface="Arial"/>
                <a:ea typeface="Arial"/>
              </a:rPr>
              <a:t>G2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8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05-30T13:39:37Z</dcterms:created>
  <dc:creator>WLiang</dc:creator>
  <dc:description/>
  <dc:language>en-US</dc:language>
  <cp:lastModifiedBy>wliang</cp:lastModifiedBy>
  <dcterms:modified xsi:type="dcterms:W3CDTF">2005-03-16T22:44:59Z</dcterms:modified>
  <cp:revision>14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-1185875801</vt:r8>
  </property>
  <property fmtid="{D5CDD505-2E9C-101B-9397-08002B2CF9AE}" pid="3" name="_AuthorEmail">
    <vt:lpwstr>wliang@tgen.org</vt:lpwstr>
  </property>
  <property fmtid="{D5CDD505-2E9C-101B-9397-08002B2CF9AE}" pid="4" name="_AuthorEmailDisplayName">
    <vt:lpwstr>Winnie Liang</vt:lpwstr>
  </property>
  <property fmtid="{D5CDD505-2E9C-101B-9397-08002B2CF9AE}" pid="5" name="_EmailSubject">
    <vt:lpwstr>more more stuff</vt:lpwstr>
  </property>
  <property fmtid="{D5CDD505-2E9C-101B-9397-08002B2CF9AE}" pid="6" name="_ReviewingToolsShownOnce">
    <vt:lpwstr/>
  </property>
</Properties>
</file>